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F227A-3BCB-48AC-983F-15767CDC1F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0FF84-D2E5-4726-A31D-EB2E4E211B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46DACC-6479-46A0-9697-8C7E348062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86A12-C54A-4F7C-8874-CBE020666D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36842-C828-427B-9514-682D93C878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C569A-7C37-404D-B3C6-E4CA8E75FC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989EA-EAA5-46A4-9169-1A43F140ED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510CE-98A6-4FB8-B4E1-F0B768D90C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BFED4-0CD2-49DD-B238-EBFAE6F32B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15800-8C4B-4C76-9E5E-8F58BE2618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80D98-1F4C-498E-A0CF-5B141D0595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14421-B9B1-4985-A654-9AB77C05CF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2BAB17-2A55-4550-87DA-E6091FDD8980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2"/>
          <p:cNvSpPr/>
          <p:nvPr/>
        </p:nvSpPr>
        <p:spPr>
          <a:xfrm>
            <a:off x="-6840" y="27000"/>
            <a:ext cx="568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Figure S1. Sampling sites of nodules, soil and plant materi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e 1"/>
          <p:cNvGrpSpPr/>
          <p:nvPr/>
        </p:nvGrpSpPr>
        <p:grpSpPr>
          <a:xfrm>
            <a:off x="11160" y="507960"/>
            <a:ext cx="7224840" cy="8024760"/>
            <a:chOff x="11160" y="507960"/>
            <a:chExt cx="7224840" cy="8024760"/>
          </a:xfrm>
        </p:grpSpPr>
        <p:grpSp>
          <p:nvGrpSpPr>
            <p:cNvPr id="43" name="Groupe 1"/>
            <p:cNvGrpSpPr/>
            <p:nvPr/>
          </p:nvGrpSpPr>
          <p:grpSpPr>
            <a:xfrm>
              <a:off x="188640" y="2639880"/>
              <a:ext cx="7047360" cy="5892840"/>
              <a:chOff x="188640" y="2639880"/>
              <a:chExt cx="7047360" cy="5892840"/>
            </a:xfrm>
          </p:grpSpPr>
          <p:grpSp>
            <p:nvGrpSpPr>
              <p:cNvPr id="44" name="Groupe 66"/>
              <p:cNvGrpSpPr/>
              <p:nvPr/>
            </p:nvGrpSpPr>
            <p:grpSpPr>
              <a:xfrm>
                <a:off x="188640" y="2639880"/>
                <a:ext cx="7047360" cy="5892840"/>
                <a:chOff x="188640" y="2639880"/>
                <a:chExt cx="7047360" cy="5892840"/>
              </a:xfrm>
            </p:grpSpPr>
            <p:pic>
              <p:nvPicPr>
                <p:cNvPr id="45" name="Picture 3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304000" y="2639880"/>
                  <a:ext cx="4395600" cy="5213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6" name="ZoneTexte 5"/>
                <p:cNvSpPr/>
                <p:nvPr/>
              </p:nvSpPr>
              <p:spPr>
                <a:xfrm>
                  <a:off x="5056920" y="6363000"/>
                  <a:ext cx="4705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16,17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pic>
              <p:nvPicPr>
                <p:cNvPr id="47" name="Picture 3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188640" y="4182840"/>
                  <a:ext cx="1332720" cy="25027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8" name="Rectangle 7"/>
                <p:cNvSpPr/>
                <p:nvPr/>
              </p:nvSpPr>
              <p:spPr>
                <a:xfrm>
                  <a:off x="1007640" y="6045840"/>
                  <a:ext cx="460080" cy="53208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Connecteur droit 8"/>
                <p:cNvSpPr/>
                <p:nvPr/>
              </p:nvSpPr>
              <p:spPr>
                <a:xfrm flipV="1">
                  <a:off x="1033200" y="2652120"/>
                  <a:ext cx="1278000" cy="1863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" name="Connecteur droit 9"/>
                <p:cNvSpPr/>
                <p:nvPr/>
              </p:nvSpPr>
              <p:spPr>
                <a:xfrm>
                  <a:off x="980640" y="5846040"/>
                  <a:ext cx="1330200" cy="1995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ZoneTexte 10"/>
                <p:cNvSpPr/>
                <p:nvPr/>
              </p:nvSpPr>
              <p:spPr>
                <a:xfrm>
                  <a:off x="188640" y="8042400"/>
                  <a:ext cx="6498000" cy="490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Rectangle 11"/>
                <p:cNvSpPr/>
                <p:nvPr/>
              </p:nvSpPr>
              <p:spPr>
                <a:xfrm>
                  <a:off x="5705640" y="6413400"/>
                  <a:ext cx="37800" cy="5040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0" bIns="36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ZoneTexte 12"/>
                <p:cNvSpPr/>
                <p:nvPr/>
              </p:nvSpPr>
              <p:spPr>
                <a:xfrm>
                  <a:off x="5637960" y="6445080"/>
                  <a:ext cx="716400" cy="398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Rio  de Janeir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ZoneTexte 13"/>
                <p:cNvSpPr/>
                <p:nvPr/>
              </p:nvSpPr>
              <p:spPr>
                <a:xfrm>
                  <a:off x="5393520" y="6234480"/>
                  <a:ext cx="4608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1,2, 3,18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ZoneTexte 14"/>
                <p:cNvSpPr/>
                <p:nvPr/>
              </p:nvSpPr>
              <p:spPr>
                <a:xfrm>
                  <a:off x="5677920" y="6161400"/>
                  <a:ext cx="318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4,5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ZoneTexte 15"/>
                <p:cNvSpPr/>
                <p:nvPr/>
              </p:nvSpPr>
              <p:spPr>
                <a:xfrm>
                  <a:off x="5110200" y="5690880"/>
                  <a:ext cx="910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inas Gerais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ZoneTexte 16"/>
                <p:cNvSpPr/>
                <p:nvPr/>
              </p:nvSpPr>
              <p:spPr>
                <a:xfrm>
                  <a:off x="4154040" y="5846400"/>
                  <a:ext cx="664920" cy="550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ato Gross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do Sul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ZoneTexte 17"/>
                <p:cNvSpPr/>
                <p:nvPr/>
              </p:nvSpPr>
              <p:spPr>
                <a:xfrm>
                  <a:off x="4078800" y="5758200"/>
                  <a:ext cx="3582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6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ZoneTexte 18"/>
                <p:cNvSpPr/>
                <p:nvPr/>
              </p:nvSpPr>
              <p:spPr>
                <a:xfrm>
                  <a:off x="6480360" y="4448880"/>
                  <a:ext cx="3582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7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ZoneTexte 19"/>
                <p:cNvSpPr/>
                <p:nvPr/>
              </p:nvSpPr>
              <p:spPr>
                <a:xfrm>
                  <a:off x="4428000" y="3568320"/>
                  <a:ext cx="595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arà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ZoneTexte 21"/>
                <p:cNvSpPr/>
                <p:nvPr/>
              </p:nvSpPr>
              <p:spPr>
                <a:xfrm>
                  <a:off x="5484600" y="5874120"/>
                  <a:ext cx="42588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10, 11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ZoneTexte 22"/>
                <p:cNvSpPr/>
                <p:nvPr/>
              </p:nvSpPr>
              <p:spPr>
                <a:xfrm>
                  <a:off x="4232160" y="3548880"/>
                  <a:ext cx="2797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9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ZoneTexte 23"/>
                <p:cNvSpPr/>
                <p:nvPr/>
              </p:nvSpPr>
              <p:spPr>
                <a:xfrm>
                  <a:off x="5692320" y="4981320"/>
                  <a:ext cx="13932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Bahia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ZoneTexte 24"/>
                <p:cNvSpPr/>
                <p:nvPr/>
              </p:nvSpPr>
              <p:spPr>
                <a:xfrm>
                  <a:off x="5637960" y="4648680"/>
                  <a:ext cx="3582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12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ZoneTexte 25"/>
                <p:cNvSpPr/>
                <p:nvPr/>
              </p:nvSpPr>
              <p:spPr>
                <a:xfrm>
                  <a:off x="5842800" y="5779800"/>
                  <a:ext cx="13932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Espirito Sant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ZoneTexte 26"/>
                <p:cNvSpPr/>
                <p:nvPr/>
              </p:nvSpPr>
              <p:spPr>
                <a:xfrm>
                  <a:off x="5842800" y="5913000"/>
                  <a:ext cx="3582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fr-FR" sz="900" spc="-1" strike="noStrike">
                      <a:solidFill>
                        <a:srgbClr val="c00000"/>
                      </a:solidFill>
                      <a:latin typeface="Calibri"/>
                    </a:rPr>
                    <a:t>15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ZoneTexte 27"/>
                <p:cNvSpPr/>
                <p:nvPr/>
              </p:nvSpPr>
              <p:spPr>
                <a:xfrm>
                  <a:off x="5805360" y="4440240"/>
                  <a:ext cx="898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ernambuc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ZoneTexte 28"/>
                <p:cNvSpPr/>
                <p:nvPr/>
              </p:nvSpPr>
              <p:spPr>
                <a:xfrm>
                  <a:off x="4819320" y="6159600"/>
                  <a:ext cx="858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ao Paul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" name="ZoneTexte 29"/>
                <p:cNvSpPr/>
                <p:nvPr/>
              </p:nvSpPr>
              <p:spPr>
                <a:xfrm>
                  <a:off x="784080" y="4848120"/>
                  <a:ext cx="8442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800" spc="-1" strike="noStrike">
                      <a:solidFill>
                        <a:srgbClr val="000000"/>
                      </a:solidFill>
                      <a:latin typeface="Calibri"/>
                    </a:rPr>
                    <a:t>Brazil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0" name="ZoneTexte 30"/>
              <p:cNvSpPr/>
              <p:nvPr/>
            </p:nvSpPr>
            <p:spPr>
              <a:xfrm>
                <a:off x="5881320" y="5342040"/>
                <a:ext cx="483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900" spc="-1" strike="noStrike">
                    <a:solidFill>
                      <a:srgbClr val="c00000"/>
                    </a:solidFill>
                    <a:latin typeface="Calibri"/>
                  </a:rPr>
                  <a:t>13,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900" spc="-1" strike="noStrike">
                    <a:solidFill>
                      <a:srgbClr val="c00000"/>
                    </a:solidFill>
                    <a:latin typeface="Calibri"/>
                  </a:rPr>
                  <a:t> </a:t>
                </a:r>
                <a:r>
                  <a:rPr b="1" lang="fr-FR" sz="900" spc="-1" strike="noStrike">
                    <a:solidFill>
                      <a:srgbClr val="c00000"/>
                    </a:solidFill>
                    <a:latin typeface="Calibri"/>
                  </a:rPr>
                  <a:t>1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1" name="ZoneTexte 31"/>
            <p:cNvSpPr/>
            <p:nvPr/>
          </p:nvSpPr>
          <p:spPr>
            <a:xfrm>
              <a:off x="11160" y="507960"/>
              <a:ext cx="3346560" cy="19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, Seropedica (RJ) (</a:t>
              </a:r>
              <a:r>
                <a:rPr b="0" lang="pt-BR" sz="1000" spc="-1" strike="noStrike">
                  <a:solidFill>
                    <a:srgbClr val="000000"/>
                  </a:solidFill>
                  <a:latin typeface="Calibri"/>
                </a:rPr>
                <a:t>22° 23’ 95 “S / 41° 49’23 O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2, Seropedica nursery (RJ) (</a:t>
              </a:r>
              <a:r>
                <a:rPr b="0" lang="pt-BR" sz="1000" spc="-1" strike="noStrike">
                  <a:solidFill>
                    <a:srgbClr val="000000"/>
                  </a:solidFill>
                  <a:latin typeface="Calibri"/>
                </a:rPr>
                <a:t>22° 44’38” S / 43° 42’28” O)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3, Experimental site Seropedica (RJ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4.1, Cabo Frio (RJ) (</a:t>
              </a:r>
              <a:r>
                <a:rPr b="0" lang="pt-BR" sz="1000" spc="-1" strike="noStrike">
                  <a:solidFill>
                    <a:srgbClr val="000000"/>
                  </a:solidFill>
                  <a:latin typeface="Calibri"/>
                </a:rPr>
                <a:t>22° 45’ 37” S / 41° 57’ 83” O) (Ppan),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Calibri"/>
                </a:rPr>
                <a:t>4.2,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abo Frio (RJ)  (</a:t>
              </a:r>
              <a:r>
                <a:rPr b="0" lang="pt-BR" sz="1000" spc="-1" strike="noStrike">
                  <a:solidFill>
                    <a:srgbClr val="000000"/>
                  </a:solidFill>
                  <a:latin typeface="Calibri"/>
                </a:rPr>
                <a:t>22° 26’ 48” S / 41° 51’ 61” O) (Pg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5, Cabo Frio – Bùzios (RJ) (</a:t>
              </a:r>
              <a:r>
                <a:rPr b="0" lang="pt-BR" sz="1000" spc="-1" strike="noStrike">
                  <a:solidFill>
                    <a:srgbClr val="000000"/>
                  </a:solidFill>
                  <a:latin typeface="Calibri"/>
                </a:rPr>
                <a:t>22° 47’ 98” S / 41° 58’ 03” O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6, Corumba (Mato Grosso do Su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7, Recife (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Pernambuco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8, Telemaco Borba, Fazenda Monte alegre (Paranà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9, Porto trombetas (Parà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, Mariana (Minas Gerais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More site details are given in Table S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ZoneTexte 32"/>
            <p:cNvSpPr/>
            <p:nvPr/>
          </p:nvSpPr>
          <p:spPr>
            <a:xfrm>
              <a:off x="3577680" y="512640"/>
              <a:ext cx="2977560" cy="1464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1, Marlièria (Minas Gerais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2, Xique-Xique (Bahia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3, Jussari (Bahia) (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5°16'46" S, 39°49'93" W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4, Itaju do Colonia (Bahia) (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15°15'99" S, 39°62'12" W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5, Linhares (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Espirito Santo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6, Instituto Florestal de Sâo Paulo (Sâo Paulo);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7, Paraibuna (Sâo Paulo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8, Paracambi (RJ), </a:t>
              </a: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22°34'49.92"S/43°41'13.90"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ZoneTexte 33"/>
            <p:cNvSpPr/>
            <p:nvPr/>
          </p:nvSpPr>
          <p:spPr>
            <a:xfrm>
              <a:off x="4534200" y="6372360"/>
              <a:ext cx="35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c00000"/>
                  </a:solidFill>
                  <a:latin typeface="Calibri"/>
                </a:rPr>
                <a:t>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ZoneTexte 34"/>
            <p:cNvSpPr/>
            <p:nvPr/>
          </p:nvSpPr>
          <p:spPr>
            <a:xfrm>
              <a:off x="4508640" y="6558120"/>
              <a:ext cx="658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arà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2T14:41:33Z</dcterms:created>
  <dc:creator> </dc:creator>
  <dc:description/>
  <dc:language>en-US</dc:language>
  <cp:lastModifiedBy> </cp:lastModifiedBy>
  <dcterms:modified xsi:type="dcterms:W3CDTF">2013-04-10T11:26:29Z</dcterms:modified>
  <cp:revision>6</cp:revision>
  <dc:subject/>
  <dc:title>Présentation PowerPoint</dc:title>
</cp:coreProperties>
</file>